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4FF0A"/>
    <a:srgbClr val="6FFFB3"/>
    <a:srgbClr val="010000"/>
    <a:srgbClr val="FF6B74"/>
    <a:srgbClr val="FFAB38"/>
    <a:srgbClr val="CD3627"/>
    <a:srgbClr val="CD75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2" autoAdjust="0"/>
    <p:restoredTop sz="94479" autoAdjust="0"/>
  </p:normalViewPr>
  <p:slideViewPr>
    <p:cSldViewPr snapToGrid="0">
      <p:cViewPr>
        <p:scale>
          <a:sx n="75" d="100"/>
          <a:sy n="75" d="100"/>
        </p:scale>
        <p:origin x="-2456" y="-25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hong:Desktop:Ron:Publications:2015%20Msmeg%20Cell-free%20system:2015%20Mtb%20Manuscript:FigS8%20raw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25:$H$25</c:f>
                <c:numCache>
                  <c:formatCode>General</c:formatCode>
                  <c:ptCount val="5"/>
                  <c:pt idx="0">
                    <c:v>10.15225032838002</c:v>
                  </c:pt>
                  <c:pt idx="1">
                    <c:v>5.807073916417485</c:v>
                  </c:pt>
                  <c:pt idx="2">
                    <c:v>7.601713891443888</c:v>
                  </c:pt>
                  <c:pt idx="3">
                    <c:v>20.03473360679349</c:v>
                  </c:pt>
                  <c:pt idx="4">
                    <c:v>0.0867108374892751</c:v>
                  </c:pt>
                </c:numCache>
              </c:numRef>
            </c:plus>
            <c:minus>
              <c:numRef>
                <c:f>Sheet1!$D$25:$H$25</c:f>
                <c:numCache>
                  <c:formatCode>General</c:formatCode>
                  <c:ptCount val="5"/>
                  <c:pt idx="0">
                    <c:v>10.15225032838002</c:v>
                  </c:pt>
                  <c:pt idx="1">
                    <c:v>5.807073916417485</c:v>
                  </c:pt>
                  <c:pt idx="2">
                    <c:v>7.601713891443888</c:v>
                  </c:pt>
                  <c:pt idx="3">
                    <c:v>20.03473360679349</c:v>
                  </c:pt>
                  <c:pt idx="4">
                    <c:v>0.0867108374892751</c:v>
                  </c:pt>
                </c:numCache>
              </c:numRef>
            </c:minus>
          </c:errBars>
          <c:val>
            <c:numRef>
              <c:f>Sheet1!$D$24:$H$24</c:f>
              <c:numCache>
                <c:formatCode>General</c:formatCode>
                <c:ptCount val="5"/>
                <c:pt idx="0">
                  <c:v>66.54205388217098</c:v>
                </c:pt>
                <c:pt idx="1">
                  <c:v>81.52423723170128</c:v>
                </c:pt>
                <c:pt idx="2">
                  <c:v>78.91237672944228</c:v>
                </c:pt>
                <c:pt idx="3">
                  <c:v>100.0</c:v>
                </c:pt>
                <c:pt idx="4">
                  <c:v>0.205597559358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0635368"/>
        <c:axId val="2099390520"/>
      </c:barChart>
      <c:catAx>
        <c:axId val="2100635368"/>
        <c:scaling>
          <c:orientation val="minMax"/>
        </c:scaling>
        <c:delete val="1"/>
        <c:axPos val="b"/>
        <c:majorTickMark val="out"/>
        <c:minorTickMark val="none"/>
        <c:tickLblPos val="nextTo"/>
        <c:crossAx val="2099390520"/>
        <c:crosses val="autoZero"/>
        <c:auto val="1"/>
        <c:lblAlgn val="ctr"/>
        <c:lblOffset val="100"/>
        <c:noMultiLvlLbl val="0"/>
      </c:catAx>
      <c:valAx>
        <c:axId val="209939052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reporter activity (%)</a:t>
                </a:r>
              </a:p>
            </c:rich>
          </c:tx>
          <c:layout>
            <c:manualLayout>
              <c:xMode val="edge"/>
              <c:yMode val="edge"/>
              <c:x val="0.00261476663722481"/>
              <c:y val="0.14314324792050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006353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96EE0-5211-8D43-85F0-F384DCFDB57E}" type="datetimeFigureOut">
              <a:rPr lang="en-US" smtClean="0"/>
              <a:t>8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395AA-AA7E-EF48-902C-80DB61661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56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2" name="Straight Connector 91"/>
          <p:cNvCxnSpPr/>
          <p:nvPr/>
        </p:nvCxnSpPr>
        <p:spPr>
          <a:xfrm>
            <a:off x="1807672" y="4639003"/>
            <a:ext cx="3913958" cy="7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937940" y="4764878"/>
            <a:ext cx="4846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RRF</a:t>
            </a:r>
            <a:r>
              <a:rPr lang="en-US" sz="1200" i="1" dirty="0" smtClean="0">
                <a:latin typeface="Times New Roman"/>
                <a:cs typeface="Times New Roman"/>
              </a:rPr>
              <a:t>		E. coli</a:t>
            </a:r>
            <a:r>
              <a:rPr lang="en-US" sz="1200" i="1" dirty="0">
                <a:latin typeface="Times New Roman"/>
                <a:cs typeface="Times New Roman"/>
              </a:rPr>
              <a:t>	 </a:t>
            </a:r>
            <a:r>
              <a:rPr lang="en-US" sz="1200" i="1" dirty="0" smtClean="0">
                <a:latin typeface="Times New Roman"/>
                <a:cs typeface="Times New Roman"/>
              </a:rPr>
              <a:t>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E. coli	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	     -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EF-G</a:t>
            </a:r>
            <a:r>
              <a:rPr lang="en-US" sz="1200" i="1" dirty="0">
                <a:latin typeface="Times New Roman"/>
                <a:cs typeface="Times New Roman"/>
              </a:rPr>
              <a:t>	</a:t>
            </a:r>
            <a:r>
              <a:rPr lang="en-US" sz="1200" i="1" dirty="0" smtClean="0">
                <a:latin typeface="Times New Roman"/>
                <a:cs typeface="Times New Roman"/>
              </a:rPr>
              <a:t>	E. coli	         E. coli	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	     -</a:t>
            </a:r>
          </a:p>
        </p:txBody>
      </p:sp>
      <p:graphicFrame>
        <p:nvGraphicFramePr>
          <p:cNvPr id="94" name="Chart 9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5458974"/>
              </p:ext>
            </p:extLst>
          </p:nvPr>
        </p:nvGraphicFramePr>
        <p:xfrm>
          <a:off x="1041344" y="2223548"/>
          <a:ext cx="4857030" cy="2579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561204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3</TotalTime>
  <Words>7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ong neb</dc:creator>
  <cp:lastModifiedBy>chong neb</cp:lastModifiedBy>
  <cp:revision>312</cp:revision>
  <cp:lastPrinted>2015-10-14T16:25:31Z</cp:lastPrinted>
  <dcterms:created xsi:type="dcterms:W3CDTF">2011-06-03T13:51:04Z</dcterms:created>
  <dcterms:modified xsi:type="dcterms:W3CDTF">2016-08-19T14:28:28Z</dcterms:modified>
</cp:coreProperties>
</file>